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237FA8-02EA-44A4-B9C9-63F74F4E16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6FC0B-3DD5-46C4-B632-513DB8D79C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EF5EB0-AE8D-46F0-A0D5-795B15EA43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46E6C-98C4-421B-AD68-CCD4BA893A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61674-723E-469C-AC1A-94E3637BCF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58F7F-7135-4810-9C65-3CCD6B5617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4057F-1CA5-48DB-881C-9991016588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E9B0F-6175-42D1-B855-9C8BBABEB0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533AA-514B-409A-AD9F-550D8E32B4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C0D96-6C98-4029-8991-9BD0427AA3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3ACE49-524D-4EA6-833B-84CCCC6316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96B366-16A7-42E2-B7AB-FDD04F57B3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C46F98-53D7-463D-91F8-EFDDD1A5300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"/>
          <p:cNvGraphicFramePr/>
          <p:nvPr/>
        </p:nvGraphicFramePr>
        <p:xfrm>
          <a:off x="1619280" y="1197000"/>
          <a:ext cx="5543640" cy="4316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19280" y="1197000"/>
                    <a:ext cx="5543640" cy="4316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 Box 3"/>
          <p:cNvSpPr/>
          <p:nvPr/>
        </p:nvSpPr>
        <p:spPr>
          <a:xfrm>
            <a:off x="1692360" y="5589720"/>
            <a:ext cx="7416720" cy="175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-Fig.1 Plasma levels of total cholesterol of rabbits fed a cholesterol diet for 28 week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明朝"/>
              </a:rPr>
              <a:t>The data were expressed as the mean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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明朝"/>
              </a:rPr>
              <a:t> SE. n =8 for non-Tg and 9 for Tg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10T02:16:58Z</dcterms:created>
  <dc:creator>T_Koike</dc:creator>
  <dc:description/>
  <dc:language>en-US</dc:language>
  <cp:lastModifiedBy>jianglin</cp:lastModifiedBy>
  <dcterms:modified xsi:type="dcterms:W3CDTF">2022-11-10T11:29:19Z</dcterms:modified>
  <cp:revision>12</cp:revision>
  <dc:subject/>
  <dc:title>スライド 1</dc:title>
</cp:coreProperties>
</file>